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</p:sldIdLst>
  <p:sldSz cx="35999738" cy="359997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EA9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20" d="100"/>
          <a:sy n="20" d="100"/>
        </p:scale>
        <p:origin x="255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99981" y="5891626"/>
            <a:ext cx="30599777" cy="12533242"/>
          </a:xfrm>
        </p:spPr>
        <p:txBody>
          <a:bodyPr anchor="b"/>
          <a:lstStyle>
            <a:lvl1pPr algn="ctr"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499967" y="18908198"/>
            <a:ext cx="26999804" cy="8691601"/>
          </a:xfrm>
        </p:spPr>
        <p:txBody>
          <a:bodyPr/>
          <a:lstStyle>
            <a:lvl1pPr marL="0" indent="0" algn="ctr">
              <a:buNone/>
              <a:defRPr sz="9449"/>
            </a:lvl1pPr>
            <a:lvl2pPr marL="1799996" indent="0" algn="ctr">
              <a:buNone/>
              <a:defRPr sz="7874"/>
            </a:lvl2pPr>
            <a:lvl3pPr marL="3599993" indent="0" algn="ctr">
              <a:buNone/>
              <a:defRPr sz="7087"/>
            </a:lvl3pPr>
            <a:lvl4pPr marL="5399989" indent="0" algn="ctr">
              <a:buNone/>
              <a:defRPr sz="6299"/>
            </a:lvl4pPr>
            <a:lvl5pPr marL="7199986" indent="0" algn="ctr">
              <a:buNone/>
              <a:defRPr sz="6299"/>
            </a:lvl5pPr>
            <a:lvl6pPr marL="8999982" indent="0" algn="ctr">
              <a:buNone/>
              <a:defRPr sz="6299"/>
            </a:lvl6pPr>
            <a:lvl7pPr marL="10799978" indent="0" algn="ctr">
              <a:buNone/>
              <a:defRPr sz="6299"/>
            </a:lvl7pPr>
            <a:lvl8pPr marL="12599975" indent="0" algn="ctr">
              <a:buNone/>
              <a:defRPr sz="6299"/>
            </a:lvl8pPr>
            <a:lvl9pPr marL="14399971" indent="0" algn="ctr">
              <a:buNone/>
              <a:defRPr sz="629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7636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1129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62314" y="1916653"/>
            <a:ext cx="7762444" cy="3050811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4984" y="1916653"/>
            <a:ext cx="22837334" cy="30508114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114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693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6234" y="8974945"/>
            <a:ext cx="31049774" cy="14974888"/>
          </a:xfrm>
        </p:spPr>
        <p:txBody>
          <a:bodyPr anchor="b"/>
          <a:lstStyle>
            <a:lvl1pPr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6234" y="24091502"/>
            <a:ext cx="31049774" cy="7874940"/>
          </a:xfrm>
        </p:spPr>
        <p:txBody>
          <a:bodyPr/>
          <a:lstStyle>
            <a:lvl1pPr marL="0" indent="0">
              <a:buNone/>
              <a:defRPr sz="9449">
                <a:solidFill>
                  <a:schemeClr val="tx1"/>
                </a:solidFill>
              </a:defRPr>
            </a:lvl1pPr>
            <a:lvl2pPr marL="1799996" indent="0">
              <a:buNone/>
              <a:defRPr sz="7874">
                <a:solidFill>
                  <a:schemeClr val="tx1">
                    <a:tint val="75000"/>
                  </a:schemeClr>
                </a:solidFill>
              </a:defRPr>
            </a:lvl2pPr>
            <a:lvl3pPr marL="3599993" indent="0">
              <a:buNone/>
              <a:defRPr sz="7087">
                <a:solidFill>
                  <a:schemeClr val="tx1">
                    <a:tint val="75000"/>
                  </a:schemeClr>
                </a:solidFill>
              </a:defRPr>
            </a:lvl3pPr>
            <a:lvl4pPr marL="5399989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4pPr>
            <a:lvl5pPr marL="7199986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5pPr>
            <a:lvl6pPr marL="8999982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6pPr>
            <a:lvl7pPr marL="10799978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7pPr>
            <a:lvl8pPr marL="12599975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8pPr>
            <a:lvl9pPr marL="14399971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7174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4982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24867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92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1916661"/>
            <a:ext cx="31049774" cy="695828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9675" y="8824938"/>
            <a:ext cx="15229574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79675" y="13149904"/>
            <a:ext cx="15229574" cy="193415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24869" y="8824938"/>
            <a:ext cx="15304578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24869" y="13149904"/>
            <a:ext cx="15304578" cy="193415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0898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3822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6519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04578" y="5183304"/>
            <a:ext cx="18224867" cy="25583147"/>
          </a:xfrm>
        </p:spPr>
        <p:txBody>
          <a:bodyPr/>
          <a:lstStyle>
            <a:lvl1pPr>
              <a:defRPr sz="12598"/>
            </a:lvl1pPr>
            <a:lvl2pPr>
              <a:defRPr sz="11024"/>
            </a:lvl2pPr>
            <a:lvl3pPr>
              <a:defRPr sz="9449"/>
            </a:lvl3pPr>
            <a:lvl4pPr>
              <a:defRPr sz="7874"/>
            </a:lvl4pPr>
            <a:lvl5pPr>
              <a:defRPr sz="7874"/>
            </a:lvl5pPr>
            <a:lvl6pPr>
              <a:defRPr sz="7874"/>
            </a:lvl6pPr>
            <a:lvl7pPr>
              <a:defRPr sz="7874"/>
            </a:lvl7pPr>
            <a:lvl8pPr>
              <a:defRPr sz="7874"/>
            </a:lvl8pPr>
            <a:lvl9pPr>
              <a:defRPr sz="7874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3693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04578" y="5183304"/>
            <a:ext cx="18224867" cy="25583147"/>
          </a:xfrm>
        </p:spPr>
        <p:txBody>
          <a:bodyPr anchor="t"/>
          <a:lstStyle>
            <a:lvl1pPr marL="0" indent="0">
              <a:buNone/>
              <a:defRPr sz="12598"/>
            </a:lvl1pPr>
            <a:lvl2pPr marL="1799996" indent="0">
              <a:buNone/>
              <a:defRPr sz="11024"/>
            </a:lvl2pPr>
            <a:lvl3pPr marL="3599993" indent="0">
              <a:buNone/>
              <a:defRPr sz="9449"/>
            </a:lvl3pPr>
            <a:lvl4pPr marL="5399989" indent="0">
              <a:buNone/>
              <a:defRPr sz="7874"/>
            </a:lvl4pPr>
            <a:lvl5pPr marL="7199986" indent="0">
              <a:buNone/>
              <a:defRPr sz="7874"/>
            </a:lvl5pPr>
            <a:lvl6pPr marL="8999982" indent="0">
              <a:buNone/>
              <a:defRPr sz="7874"/>
            </a:lvl6pPr>
            <a:lvl7pPr marL="10799978" indent="0">
              <a:buNone/>
              <a:defRPr sz="7874"/>
            </a:lvl7pPr>
            <a:lvl8pPr marL="12599975" indent="0">
              <a:buNone/>
              <a:defRPr sz="7874"/>
            </a:lvl8pPr>
            <a:lvl9pPr marL="14399971" indent="0">
              <a:buNone/>
              <a:defRPr sz="787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6480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4982" y="1916661"/>
            <a:ext cx="31049774" cy="6958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4982" y="9583264"/>
            <a:ext cx="31049774" cy="228415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4982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24913" y="33366432"/>
            <a:ext cx="12149912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24815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135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599993" rtl="0" eaLnBrk="1" latinLnBrk="0" hangingPunct="1">
        <a:lnSpc>
          <a:spcPct val="90000"/>
        </a:lnSpc>
        <a:spcBef>
          <a:spcPct val="0"/>
        </a:spcBef>
        <a:buNone/>
        <a:defRPr sz="1732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99998" indent="-899998" algn="l" defTabSz="3599993" rtl="0" eaLnBrk="1" latinLnBrk="0" hangingPunct="1">
        <a:lnSpc>
          <a:spcPct val="90000"/>
        </a:lnSpc>
        <a:spcBef>
          <a:spcPts val="3937"/>
        </a:spcBef>
        <a:buFont typeface="Arial" panose="020B0604020202020204" pitchFamily="34" charset="0"/>
        <a:buChar char="•"/>
        <a:defRPr sz="11024" kern="1200">
          <a:solidFill>
            <a:schemeClr val="tx1"/>
          </a:solidFill>
          <a:latin typeface="+mn-lt"/>
          <a:ea typeface="+mn-ea"/>
          <a:cs typeface="+mn-cs"/>
        </a:defRPr>
      </a:lvl1pPr>
      <a:lvl2pPr marL="2699995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2pPr>
      <a:lvl3pPr marL="4499991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3pPr>
      <a:lvl4pPr marL="629998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8099984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9899980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169997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3499973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5299969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1pPr>
      <a:lvl2pPr marL="179999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2pPr>
      <a:lvl3pPr marL="3599993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3pPr>
      <a:lvl4pPr marL="5399989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719998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8999982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0799978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2599975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4399971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AE950B4-89D3-4E2A-A3F1-6DF20248C2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37594083"/>
              </p:ext>
            </p:extLst>
          </p:nvPr>
        </p:nvGraphicFramePr>
        <p:xfrm>
          <a:off x="126291" y="554052"/>
          <a:ext cx="35747155" cy="2907792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936250">
                  <a:extLst>
                    <a:ext uri="{9D8B030D-6E8A-4147-A177-3AD203B41FA5}">
                      <a16:colId xmlns:a16="http://schemas.microsoft.com/office/drawing/2014/main" val="499345670"/>
                    </a:ext>
                  </a:extLst>
                </a:gridCol>
                <a:gridCol w="4176459">
                  <a:extLst>
                    <a:ext uri="{9D8B030D-6E8A-4147-A177-3AD203B41FA5}">
                      <a16:colId xmlns:a16="http://schemas.microsoft.com/office/drawing/2014/main" val="1758963952"/>
                    </a:ext>
                  </a:extLst>
                </a:gridCol>
                <a:gridCol w="4152900">
                  <a:extLst>
                    <a:ext uri="{9D8B030D-6E8A-4147-A177-3AD203B41FA5}">
                      <a16:colId xmlns:a16="http://schemas.microsoft.com/office/drawing/2014/main" val="3863973819"/>
                    </a:ext>
                  </a:extLst>
                </a:gridCol>
                <a:gridCol w="5295900">
                  <a:extLst>
                    <a:ext uri="{9D8B030D-6E8A-4147-A177-3AD203B41FA5}">
                      <a16:colId xmlns:a16="http://schemas.microsoft.com/office/drawing/2014/main" val="2613630306"/>
                    </a:ext>
                  </a:extLst>
                </a:gridCol>
                <a:gridCol w="2552700">
                  <a:extLst>
                    <a:ext uri="{9D8B030D-6E8A-4147-A177-3AD203B41FA5}">
                      <a16:colId xmlns:a16="http://schemas.microsoft.com/office/drawing/2014/main" val="242835973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1621451540"/>
                    </a:ext>
                  </a:extLst>
                </a:gridCol>
                <a:gridCol w="4305300">
                  <a:extLst>
                    <a:ext uri="{9D8B030D-6E8A-4147-A177-3AD203B41FA5}">
                      <a16:colId xmlns:a16="http://schemas.microsoft.com/office/drawing/2014/main" val="1653545787"/>
                    </a:ext>
                  </a:extLst>
                </a:gridCol>
                <a:gridCol w="3314700">
                  <a:extLst>
                    <a:ext uri="{9D8B030D-6E8A-4147-A177-3AD203B41FA5}">
                      <a16:colId xmlns:a16="http://schemas.microsoft.com/office/drawing/2014/main" val="3370541341"/>
                    </a:ext>
                  </a:extLst>
                </a:gridCol>
                <a:gridCol w="5676900">
                  <a:extLst>
                    <a:ext uri="{9D8B030D-6E8A-4147-A177-3AD203B41FA5}">
                      <a16:colId xmlns:a16="http://schemas.microsoft.com/office/drawing/2014/main" val="2822472439"/>
                    </a:ext>
                  </a:extLst>
                </a:gridCol>
                <a:gridCol w="2497846">
                  <a:extLst>
                    <a:ext uri="{9D8B030D-6E8A-4147-A177-3AD203B41FA5}">
                      <a16:colId xmlns:a16="http://schemas.microsoft.com/office/drawing/2014/main" val="3188825772"/>
                    </a:ext>
                  </a:extLst>
                </a:gridCol>
              </a:tblGrid>
              <a:tr h="370840">
                <a:tc gridSpan="5">
                  <a:txBody>
                    <a:bodyPr/>
                    <a:lstStyle/>
                    <a:p>
                      <a:r>
                        <a:rPr lang="en-US" altLang="zh-CN" sz="44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art 1</a:t>
                      </a:r>
                      <a:endParaRPr lang="zh-CN" altLang="en-US" sz="44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art 2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19359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diator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od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o of SNPs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R(95%CI)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 valu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od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o of SNPs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R(95%CI)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 valu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6477697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atching TV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70 (0.653 to 0.657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8e-22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53 (0.418 to 0.492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9e-8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363208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7087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44 (0.584 to 0.710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e-16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68 (0.325 to 0.674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7e-05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9188143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7087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93 (0.674 to 0.712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e-15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36 (0.502 to 0.572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e-7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2846829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7087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74 (0.660 to 0.689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1e-11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4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73 (0.444 to 0.503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e-4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7946103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HBG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16 (1.016 to 1.225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2e-0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6 (0.990 to 1.021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8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5360886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7087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5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48 (0.792 to 1.663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7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82 (0.955 to 1.009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4519342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7087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5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21 (0.971 to 1.073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2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3 (0.986 to 1.020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5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7141972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7087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1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46 (1.004 to 1.088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e-0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3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13 (0.999 to 1.026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2e-0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9103361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moking</a:t>
                      </a: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itiatio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89 (0.646 to 0.734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e-3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23 (0.784 to  0.865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e-1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5783951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8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31 (0.570 to 0.939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e-0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60 (0.669 to 1.104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3e-1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811309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8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25 (0.680 to 0.773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9e-2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68 (0.835 to 0.902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2232954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8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94 (0.656 to 0.731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3e-3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8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32 (0.804 to 0.860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e-16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8372476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FP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0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48 (0.720 to 0.777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e-5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4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80 (0.745 to 0.817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2e-2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24356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8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0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35 (0.633 to 0.854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2e-05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4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82 (0.926 to 1.263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2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1127401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8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0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59 (0.734 to 0.784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e-6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4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39 (0.810 to 0.868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e-2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1594841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8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8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46 (0.725 to 0.768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7e-56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9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81 (0.758 to 0.806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e-3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1281757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MI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09 (0.673 to 0.746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5e-3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05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36 (0.813 to 0.860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2e-36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228794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20 (0.587 to 0.883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e-0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05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94 (0.924 to 1.069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6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809153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52 (0.722 to 0.783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6e-4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05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83 (0.864 to 0.903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1e-2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0751140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6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12 (0.687 to 0.737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e-5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1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29 (0.813 to 0.844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3e-6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5182267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D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54 (1.081 to 1.233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9e-05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15 (0.995 to 1.035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5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08400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77 (0.815 to 1.423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0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94 (0.963 to 1.026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0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3603322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43 (1.049 to 1.246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2e-0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99 (0.985 to 1.012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9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619371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62 (1.095 to 1.230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6e-0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7 (0.994 to 1.020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8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2866311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ajor</a:t>
                      </a: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epression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86 (0.732 to 0.843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2e-1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24 (0.863 to 0.989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e-0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803353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84 (0.667 to 1.172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8 (0.696 to 1.459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e-0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2323434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90 (0.736 to 0.848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8e-1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53 (0.919 to 0.990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6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0462676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09 (0.763 to 0.854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e-1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36 (0.903 to 0.970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e-0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6359716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sing</a:t>
                      </a: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mputer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01 (1.359 to 1.444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e-10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72 (1.695 to 2.068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7e-35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4445936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77 (1.310 to 1.667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4e-1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919 (1.138 to 3.235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e-0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4740197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46 (1.305 to 1.388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e-7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84 (1.562 to 1.815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0e-4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786396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6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82 (1.346 to 1.419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8e-7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4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909 (1.781 to 2.036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8e-2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693057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itting</a:t>
                      </a:r>
                    </a:p>
                    <a:p>
                      <a:pPr algn="ctr"/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eigh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61 (1.103 to 1.222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9e-0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5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81 (1.061 to 1.102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e-15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8566098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72 (0.876 to 1.311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0e-0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5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83 (1.037 to 1.131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3e-0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8319892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85 (1.056 to 1.116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3e-0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5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65 (1.047 to 1.085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2e-1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1131630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altLang="zh-CN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0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02 (1.076 to 1.129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9e-1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3*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70 (1.056 to 1.084)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e-2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14986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95609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02</TotalTime>
  <Words>763</Words>
  <Application>Microsoft Office PowerPoint</Application>
  <PresentationFormat>自定义</PresentationFormat>
  <Paragraphs>32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任震晓</dc:creator>
  <cp:lastModifiedBy>任震晓</cp:lastModifiedBy>
  <cp:revision>345</cp:revision>
  <dcterms:created xsi:type="dcterms:W3CDTF">2023-07-13T08:08:32Z</dcterms:created>
  <dcterms:modified xsi:type="dcterms:W3CDTF">2024-03-05T13:06:32Z</dcterms:modified>
</cp:coreProperties>
</file>